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32B18D-8FB3-411A-B13A-025CB5B865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282EB2C-3A70-4B1B-BDF7-4790386110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604536-EF7C-4EC3-8B54-796C810D4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4BE691-EBFD-4125-9A77-17DEACA72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ABA73E-995A-481A-A8AA-9B818A9A8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2219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AB7B0C-2230-44D9-9820-16E51D39B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896BD09-5C45-4FC5-AAFD-5CE56EAF59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F8197B-7946-466D-8EE6-FEB81C919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8D9BF4-76ED-4D45-8A6F-52BD10EDE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E32A2C-7D92-4E27-812F-3780EFE0B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604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4B0574C-AB75-4F54-81CA-1221301AC8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82EFC93-02BB-4F47-B33F-A3B7B6EA62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18D7BB-5A93-46DB-BAF6-21D637C9D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5F9213-4433-470A-A107-D72AB418C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836B9-6EDB-457F-BFAB-4E3B392DF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544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90CE58-784B-4912-BFAA-E18E20DB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F6D7F-6898-4A6A-9C3E-5C5ED433AB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605E74-E1D0-46F5-9EDB-3B76B0A79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18F269-C314-4B76-A5FC-ABA36FED0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5EAA83-E699-402A-8A36-596FFFA47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054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BB9AB9-16AB-41A8-84C0-E80C09559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FECCCEB-4621-4122-8ED5-C80D26324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BCFA3C-54C8-4765-8DC7-C0BF77F03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E02D78-F0CE-40EC-A4EE-E2300B1AB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051996-5527-4403-B63A-48BCC697A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479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0D58BB-FFA9-4A3B-8BDE-288693F66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FEDF4C-D9D3-4D99-BB69-037FF2C188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F8C41B-E3BF-4489-B24E-54FF9CDF4C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26BD6F-BDD7-4CB8-BA5F-115996694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210B1F6-93CD-4703-8714-7D00482CE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2DDFE-B8D8-49FC-8865-9BA8F929B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55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F7E5D7-D5AD-4D24-BB5E-2733C0A6B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DBF1350-435E-4B2E-8BC4-251E73AD2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29D3E6-2A4D-43D3-8CF1-A0FBFF9A22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C767BCB-AD93-490A-BE26-80BC55E672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B12E95B-898E-4236-968F-F885C142F6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BE80B3A-D7D2-48F0-9B37-EACDA35CC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BD071D5-B071-4D61-A2B6-C74AF3B35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9D1517D-C0A1-4960-BEA4-DF9F0E1AC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8744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3FE2A1-2EAB-427C-8E71-3D5646599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AAC22E2-D91E-497E-B577-88B3AE2CE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1CA680-36F2-4B9D-B404-7F0F69FE4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921BEED-B261-4DE5-98C0-42EED8FCD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9281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23451DC-1AAE-45E3-9D99-103E66675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EDFE02F-772F-495A-809B-C20DA271F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517153A-3A5D-4DC4-B91A-154B931FE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49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901232-639E-47FF-AD3C-2744958DB8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251C4D-4B70-4DC9-8EA7-C8F40E7A07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C99D91C-B1D1-4C72-B124-1FA17F493E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9F0F5C-6505-4253-A094-E0953D4A7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85B4FE-303B-42B3-B3AD-AF09D93D7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335734-8B58-4070-AE0F-B6DE40047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424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0B0406-7CA7-4C90-BB64-90F2560A7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B497D11-F7A3-402B-AA63-58C0F4C202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58E45E8-EF4E-4F20-A753-1EE9A69479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B26362-DA1C-40E2-A96E-74894D97F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24638F-2472-4AFA-B43B-A88DD038D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3E4927-1475-4814-830D-9F91FAC90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396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72B558-8003-4CDD-AE82-9AA5100B72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6055622-36E8-45C3-B470-EEA8BBD588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259C23-B9B6-4CE4-9146-5A42E75CD7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7A0EE-095E-4CE0-ACAB-8006C6AE99D6}" type="datetimeFigureOut">
              <a:rPr kumimoji="1" lang="ja-JP" altLang="en-US" smtClean="0"/>
              <a:t>2021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5FEA82-5FEC-417B-B5F9-5C1FD7B9B4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B5DB0C-5443-4EAE-8DE0-DECAA9E99B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D7338-A344-4358-B49B-A8A373EC24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286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1FF2A8F-8C74-4D00-ACB0-77CCF5B9FC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486" t="7778" r="30314" b="3503"/>
          <a:stretch/>
        </p:blipFill>
        <p:spPr>
          <a:xfrm>
            <a:off x="8577448" y="790576"/>
            <a:ext cx="3240771" cy="4518828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4091741-1BED-414B-81C8-12C667198834}"/>
              </a:ext>
            </a:extLst>
          </p:cNvPr>
          <p:cNvSpPr txBox="1"/>
          <p:nvPr/>
        </p:nvSpPr>
        <p:spPr>
          <a:xfrm>
            <a:off x="8658779" y="899232"/>
            <a:ext cx="3905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3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FC4737A-D63D-45BE-A461-0FE80AFB7F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223" b="6513"/>
          <a:stretch/>
        </p:blipFill>
        <p:spPr>
          <a:xfrm>
            <a:off x="491941" y="790576"/>
            <a:ext cx="3689534" cy="451882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23C782-EFCD-4E6E-8E94-8B316CA98FB8}"/>
              </a:ext>
            </a:extLst>
          </p:cNvPr>
          <p:cNvSpPr txBox="1"/>
          <p:nvPr/>
        </p:nvSpPr>
        <p:spPr>
          <a:xfrm>
            <a:off x="639001" y="899232"/>
            <a:ext cx="3905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577BCB10-A596-4F6C-8906-43EF8338531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228" t="7587" r="13004" b="11477"/>
          <a:stretch/>
        </p:blipFill>
        <p:spPr>
          <a:xfrm>
            <a:off x="4348046" y="790576"/>
            <a:ext cx="4062830" cy="451882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CE4EC7D-E106-4DB1-A2DC-B6AA5CB86F94}"/>
              </a:ext>
            </a:extLst>
          </p:cNvPr>
          <p:cNvSpPr txBox="1"/>
          <p:nvPr/>
        </p:nvSpPr>
        <p:spPr>
          <a:xfrm>
            <a:off x="4516420" y="899232"/>
            <a:ext cx="3905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A4E7EEF-D904-4041-9E10-0376CC425D58}"/>
              </a:ext>
            </a:extLst>
          </p:cNvPr>
          <p:cNvSpPr txBox="1"/>
          <p:nvPr/>
        </p:nvSpPr>
        <p:spPr>
          <a:xfrm>
            <a:off x="352425" y="5418060"/>
            <a:ext cx="1146579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. Examples of abnormal MRI findings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xial T1-weighted sequence at 6 days of age showing a focal high signal intensity lesion of the white matter (Patient No. 2). B. Axial T1-weighted sequence at 2 days of age showing bilateral high signal intensity lesions in the globus pallidus and subthalamic nuclei (Patient No. 5). C. Axial T1-weighted sequence at 25 days of age showing bilateral high signal intensity changes and atrophy in the basal ganglia and thalamus as well as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cystic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ncephalomalacia in the greater part of the bilateral cerebral hemispheres (Patient No. 8).</a:t>
            </a:r>
          </a:p>
        </p:txBody>
      </p:sp>
    </p:spTree>
    <p:extLst>
      <p:ext uri="{BB962C8B-B14F-4D97-AF65-F5344CB8AC3E}">
        <p14:creationId xmlns:p14="http://schemas.microsoft.com/office/powerpoint/2010/main" val="2194997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12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青木良則</dc:creator>
  <cp:lastModifiedBy>青木　良則</cp:lastModifiedBy>
  <cp:revision>6</cp:revision>
  <dcterms:created xsi:type="dcterms:W3CDTF">2021-01-27T09:40:57Z</dcterms:created>
  <dcterms:modified xsi:type="dcterms:W3CDTF">2021-04-11T14:47:24Z</dcterms:modified>
</cp:coreProperties>
</file>